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58" r:id="rId4"/>
    <p:sldId id="259" r:id="rId5"/>
    <p:sldId id="260" r:id="rId6"/>
    <p:sldId id="264" r:id="rId7"/>
    <p:sldId id="265" r:id="rId8"/>
    <p:sldId id="266" r:id="rId9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2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24A0A-58FF-F12F-C7EE-55A637AE22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B4EA07-D9C8-0874-7CE7-571666D926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2D6FB3-D5BA-A0EA-25DE-F35BBCDEB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76CD04-377B-0A3F-35A1-6F9F0C7AD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DD39ED-91BA-21DA-B26E-91D6E08A4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88106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71BEF0-60E2-2A13-6D0F-6A67C742AB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B26E3C-40AC-DB44-8327-D1634E0B3F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424447-D360-A826-78CB-D351D8246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FC3E58-FD65-A313-096F-CFEC4CA20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A78B9D-FD34-FFB6-92AD-891F310AF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80976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1B1934-CC0B-C574-F77D-2FCC6CDAD9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FBA4A7-3667-CFDA-66A3-7C5B83B12B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14168A-F889-07E0-5ADF-B11517543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9DC861-61D5-FD6B-2A41-DE25D1984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603463-6814-1FF5-F86E-D61FD2152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90633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C93B5-24DC-6914-D746-8BC2A85195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AF2E7F-F271-EDFE-B074-7A02307170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1A23B0-FC0D-3A83-C62A-3FB1EC744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3FEF5-0FDF-36D8-12E8-A147C00CB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CB457E-3838-4510-84AE-6C15CF351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68251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ED153-4B39-854D-C7AF-5AB56DDD90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9B836D-BA69-2031-5268-06FBE5AD7A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33E51D-64FA-F6EE-6228-34610FF7D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F9458-65C5-6E9D-DB6A-1961117735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19319-B41B-FBC0-6B4F-95AB9987B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65760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3A14C-A940-5C9B-8719-A7427BD081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886762-AA46-D0DB-08C3-4AC2471952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A424CC-3929-6531-2919-F97573D710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956D7A-C121-85F3-3417-948FAB3E9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03F583-C7D6-1F26-A7D6-BD8F5BB4A8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02FE53-E237-B704-51AF-A3829BE97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46794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B5390E-B583-DD7B-8BA3-6FFBB6AC8A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616A25-2EE1-3139-41B1-67CC3087FE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3318E7-C844-CF2E-54D6-2308A6B598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F78086-AE2E-9D16-BC32-BCC30E5F6C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CA33BD-5874-6A80-97BE-B4CD483474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DF5502-391B-CFD2-5510-233B4F22F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631CA1-C777-71C6-7827-FAB38AF52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B9CD388-1D63-9714-3026-B669A345A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16371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AB62B8-BF11-BCBD-6F09-5DDD1B289F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C85919-048E-BDE5-F7C3-80B4614FC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DA7A1F-672F-6C59-BBFF-D90C89831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185369-C49C-F958-79F1-3C3FED4F3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80414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F403AC3-59DA-059B-CFF5-66A3074EE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79D75E-890B-9363-EEC7-81B9E8FA4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C81115-8589-FBE2-EFA0-546DE3778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98545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B034B-F142-D065-D830-56AE8C7B8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50A164-ABC3-3EA2-502F-0C49FBFDF2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F5F3C1-766B-19AB-81A2-AD0FB04951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0724A6-0CC0-35A7-2164-CC030425D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B0CF57-3C90-D5E9-59D6-F829A56D2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C5D82B-A71A-CDBB-2F77-744743449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54700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114F29-7B53-3242-ED85-FF25F1DCCD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74FA53-8FA4-4418-2C37-EA22A95E74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4BE4EB-02B8-2053-2B62-79A4FB65AC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0F712-7361-B034-5F71-BCDCD2AA3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0A4285-3D8A-55B2-0B2D-533A72ACC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5F8123-51D6-8FD4-6E9D-A78E27AF3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36585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BEFB4A-9AE9-012B-EA8E-5D02C4CF4C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A6219F-CCA5-3EC9-CA47-8E974BD76F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88F00A-0307-318F-793D-319CCC6BDB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39F41-EC14-4E7C-821C-EFE1BA2BAEBB}" type="datetimeFigureOut">
              <a:rPr lang="nb-NO" smtClean="0"/>
              <a:t>22.08.2023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021E86-C767-3311-AE7C-4C6E5D7D4E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2B026D-EA4B-4FAD-D798-D708A8E597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1739F-7DCF-4400-B003-07BD2513D2D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92054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purple stain&#10;&#10;Description automatically generated">
            <a:extLst>
              <a:ext uri="{FF2B5EF4-FFF2-40B4-BE49-F238E27FC236}">
                <a16:creationId xmlns:a16="http://schemas.microsoft.com/office/drawing/2014/main" id="{16A4E0A9-BCDF-2ADE-C6C2-507F3E60D0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1639" y="0"/>
            <a:ext cx="6968722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9438517-7517-8CFA-4508-C488AE7990BF}"/>
              </a:ext>
            </a:extLst>
          </p:cNvPr>
          <p:cNvSpPr txBox="1"/>
          <p:nvPr/>
        </p:nvSpPr>
        <p:spPr>
          <a:xfrm>
            <a:off x="0" y="96253"/>
            <a:ext cx="12296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Operculum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9812521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blue liquid&#10;&#10;Description automatically generated">
            <a:extLst>
              <a:ext uri="{FF2B5EF4-FFF2-40B4-BE49-F238E27FC236}">
                <a16:creationId xmlns:a16="http://schemas.microsoft.com/office/drawing/2014/main" id="{3B03897C-2E0D-A491-401E-E1B975FBC2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614" y="0"/>
            <a:ext cx="6900772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56AD132-2116-6B64-8667-EF20CB27D664}"/>
              </a:ext>
            </a:extLst>
          </p:cNvPr>
          <p:cNvSpPr txBox="1"/>
          <p:nvPr/>
        </p:nvSpPr>
        <p:spPr>
          <a:xfrm>
            <a:off x="0" y="0"/>
            <a:ext cx="12296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Operculum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8625005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some seaweed&#10;&#10;Description automatically generated">
            <a:extLst>
              <a:ext uri="{FF2B5EF4-FFF2-40B4-BE49-F238E27FC236}">
                <a16:creationId xmlns:a16="http://schemas.microsoft.com/office/drawing/2014/main" id="{AE70C450-889C-4116-F6AB-DFB3C1E80A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769" y="0"/>
            <a:ext cx="6934461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6ACC408-50D6-A733-D9DE-7BC808756214}"/>
              </a:ext>
            </a:extLst>
          </p:cNvPr>
          <p:cNvSpPr txBox="1"/>
          <p:nvPr/>
        </p:nvSpPr>
        <p:spPr>
          <a:xfrm>
            <a:off x="0" y="0"/>
            <a:ext cx="5693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Skin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41788441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white surface&#10;&#10;Description automatically generated">
            <a:extLst>
              <a:ext uri="{FF2B5EF4-FFF2-40B4-BE49-F238E27FC236}">
                <a16:creationId xmlns:a16="http://schemas.microsoft.com/office/drawing/2014/main" id="{C6CEA62C-404F-5BE6-6BAB-B6737EE802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889" y="0"/>
            <a:ext cx="6986221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F5B6854-0D11-7E7B-107C-56515C6F8218}"/>
              </a:ext>
            </a:extLst>
          </p:cNvPr>
          <p:cNvSpPr txBox="1"/>
          <p:nvPr/>
        </p:nvSpPr>
        <p:spPr>
          <a:xfrm>
            <a:off x="0" y="0"/>
            <a:ext cx="5693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Skin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1784857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microscope slide&#10;&#10;Description automatically generated">
            <a:extLst>
              <a:ext uri="{FF2B5EF4-FFF2-40B4-BE49-F238E27FC236}">
                <a16:creationId xmlns:a16="http://schemas.microsoft.com/office/drawing/2014/main" id="{E1ADED20-4A5F-F311-DFC5-D301F212F0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9776" y="0"/>
            <a:ext cx="6832448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18D4498-9757-C6E7-5F27-B991AE100E65}"/>
              </a:ext>
            </a:extLst>
          </p:cNvPr>
          <p:cNvSpPr txBox="1"/>
          <p:nvPr/>
        </p:nvSpPr>
        <p:spPr>
          <a:xfrm>
            <a:off x="0" y="0"/>
            <a:ext cx="11240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Caudal fin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4494930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microscope slide&#10;&#10;Description automatically generated">
            <a:extLst>
              <a:ext uri="{FF2B5EF4-FFF2-40B4-BE49-F238E27FC236}">
                <a16:creationId xmlns:a16="http://schemas.microsoft.com/office/drawing/2014/main" id="{C0C57F4D-D9F3-D65A-9C03-A2AF30A6E8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4414" y="0"/>
            <a:ext cx="6883171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B41BD2E-8BFF-ABD5-4B56-A29C9208EFBB}"/>
              </a:ext>
            </a:extLst>
          </p:cNvPr>
          <p:cNvSpPr txBox="1"/>
          <p:nvPr/>
        </p:nvSpPr>
        <p:spPr>
          <a:xfrm>
            <a:off x="0" y="0"/>
            <a:ext cx="11240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Caudal fin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4561986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purple and white object&#10;&#10;Description automatically generated">
            <a:extLst>
              <a:ext uri="{FF2B5EF4-FFF2-40B4-BE49-F238E27FC236}">
                <a16:creationId xmlns:a16="http://schemas.microsoft.com/office/drawing/2014/main" id="{E6FC7519-E560-1E04-E0D8-582E8F2B51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6395" y="0"/>
            <a:ext cx="6899210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0F5AC0E-1A38-2D31-52D1-C063E15B781B}"/>
              </a:ext>
            </a:extLst>
          </p:cNvPr>
          <p:cNvSpPr txBox="1"/>
          <p:nvPr/>
        </p:nvSpPr>
        <p:spPr>
          <a:xfrm>
            <a:off x="0" y="0"/>
            <a:ext cx="12454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Pectoral fin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1637464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F5F45F4-D9F7-56FD-C182-42E93D49EDA9}"/>
              </a:ext>
            </a:extLst>
          </p:cNvPr>
          <p:cNvSpPr txBox="1"/>
          <p:nvPr/>
        </p:nvSpPr>
        <p:spPr>
          <a:xfrm>
            <a:off x="0" y="0"/>
            <a:ext cx="12454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Pectoral fin</a:t>
            </a:r>
          </a:p>
          <a:p>
            <a:endParaRPr lang="nb-NO" dirty="0"/>
          </a:p>
        </p:txBody>
      </p:sp>
      <p:pic>
        <p:nvPicPr>
          <p:cNvPr id="4" name="Picture 3" descr="A microscope view of a cell&#10;&#10;Description automatically generated">
            <a:extLst>
              <a:ext uri="{FF2B5EF4-FFF2-40B4-BE49-F238E27FC236}">
                <a16:creationId xmlns:a16="http://schemas.microsoft.com/office/drawing/2014/main" id="{A55F5AA1-417A-7DCF-002A-6D9BD31FB6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4893" y="0"/>
            <a:ext cx="67822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8444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2</Words>
  <Application>Microsoft Office PowerPoint</Application>
  <PresentationFormat>Widescreen</PresentationFormat>
  <Paragraphs>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e Sveen</dc:creator>
  <cp:lastModifiedBy>Lene Sveen</cp:lastModifiedBy>
  <cp:revision>2</cp:revision>
  <dcterms:created xsi:type="dcterms:W3CDTF">2023-08-22T07:05:43Z</dcterms:created>
  <dcterms:modified xsi:type="dcterms:W3CDTF">2023-08-22T07:12:32Z</dcterms:modified>
</cp:coreProperties>
</file>